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  <p:sldId id="287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0"/>
    <p:restoredTop sz="96291"/>
  </p:normalViewPr>
  <p:slideViewPr>
    <p:cSldViewPr snapToGrid="0" snapToObjects="1">
      <p:cViewPr varScale="1">
        <p:scale>
          <a:sx n="147" d="100"/>
          <a:sy n="147" d="100"/>
        </p:scale>
        <p:origin x="67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8255A9E-8649-784A-9CB4-BAE66FC70F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9276EF53-B475-3940-9136-EFF26BB556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292DE04-95E9-A146-AAF1-871C57B01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3FA6FF0-019C-7341-9DF9-08FF06567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1443CAD-630A-B742-B02B-89C6007D2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2599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7585021-512D-1247-B0EB-742CE82BB1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7A43D79-F2FC-FB4D-AA5C-056162BE43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08294B0-BEE4-654E-A0BD-AFDA381E9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1FD6110-8BA3-2F42-A13C-96F7C3CEE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3003515-00CD-6949-82E9-03D341339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8828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D6ACECA2-F1E6-5147-8B79-4D890DBC0B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5946E15-184B-0542-9355-0B27C2628D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3046938-03EE-D344-8E81-943ED48AE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AFAFD15-DC4B-5246-B560-64D3B13353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F8563DC-6FD0-9B40-89AE-C1B8CC982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0895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8D37599-6F2C-7047-900F-A06F5D339F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1186E4D-254E-094E-B9AE-C55E790921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FE3E4FD-8FC5-454E-81D8-F16E8D76D2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C5B07A-ADAC-2C4D-B2A1-40034B3CD6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6ECEF66-4FCD-F04B-8E9B-F927570DF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7113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7919A95-D6B1-3E45-BA6D-83DAD91E0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39F0EEE-0D6E-B940-B60E-EB733E313B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1D3258A-8F6B-054C-908E-0D6C8ED84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3D17BFD-65A9-EF49-98C1-EE0B8878E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4975C5D-EF1C-2641-9176-8965AC7C3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4090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81049AC-8017-7E4D-A1AF-29BC6BF55C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7376C2A-CBB9-9240-AF8A-5DDC4CC781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72575A7-2668-BF41-AA57-60D1F2EDB0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FA5FC04-21D8-DE44-9146-EA5E339B1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3988466-CC82-1E4C-AEA2-4CA531048E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1FE26B5-6FF5-A644-BC80-8D3420B58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0074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4818A5D-2E7C-FF43-9919-B0E4B0AEA1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7EC398C-DBC4-484B-B987-04D4BD4392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C33982-764C-C84B-B541-327EEB18AB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D3B56E34-F26E-204A-89E0-14A89A6537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094BD0D-0149-EB42-B259-4CC3634DF2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A12BDF5-4748-604B-A1FF-EF70892C3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C250C37-8E14-404E-A2FC-98662C65A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7AEA0207-0E7A-7741-9CF4-BCB952222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8509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CC50DEE-3F3E-2247-A7C8-A31F6F22AE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244DCEA-36D9-A148-8DB1-D92EC387F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F51E82A-B7A0-9E4C-A186-4E5C5DE6C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7B97780B-9764-9D41-8C65-BA460D9F2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1849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B933C0A-8216-B647-B88A-6675CDE7A7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84CD9AA-1579-5E4F-8FA9-A0B455A12D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E4C7F0F-8A76-EC49-B85A-5A3717171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2389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8FF2AC3-0B26-AE42-9801-6A98B80AD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74BC05B-AB99-3F45-B768-A7F41DC68D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C59769E-1DE9-6B49-9E30-CCDCD15191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13DE11C-B54D-5645-90F6-CAEC3A2EE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11D6A22-8B21-AC4C-92D5-63CD10853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7078DF5-F965-3C45-BD39-6F26F46472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1964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99D623-8D39-C642-816C-59871DFAD8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423C8ABA-DA82-BC44-9B76-7D064028D9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8EB2DDD-AF6F-6B40-B844-441EF1F8F6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9AE9CEB-BDEC-0E49-8A3F-467357FA9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61CF1C0-10D6-494D-9DCD-34AE8318D8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60949F3-A789-784E-BC1C-3CC04B375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5995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259DD3-4028-FB47-A3F9-072E228D3E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FB1A222-F696-5A44-AB25-CC15683129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1D36551-F09B-D444-8F4F-B04E2188A9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EDBF80-9F28-6A45-8BCB-7C997824B43F}" type="datetimeFigureOut">
              <a:rPr lang="fr-FR" smtClean="0"/>
              <a:t>26/05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E464CF-0A25-9040-9085-8733FDEB42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E02AD01-A29B-C049-A47B-84DCCD467B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3D934-7B45-F24A-96F4-2EF013BA9D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0581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00E8D9C9-F588-EB4E-966A-AA377224D7AC}"/>
              </a:ext>
            </a:extLst>
          </p:cNvPr>
          <p:cNvSpPr/>
          <p:nvPr/>
        </p:nvSpPr>
        <p:spPr>
          <a:xfrm>
            <a:off x="0" y="10267"/>
            <a:ext cx="12192000" cy="415381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506D248D-216B-8146-8DD0-CA9FE908BA67}"/>
              </a:ext>
            </a:extLst>
          </p:cNvPr>
          <p:cNvSpPr txBox="1"/>
          <p:nvPr/>
        </p:nvSpPr>
        <p:spPr>
          <a:xfrm>
            <a:off x="0" y="38520"/>
            <a:ext cx="2065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estern Blot Fig. 3E</a:t>
            </a:r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BBBAB4F7-63B2-2D42-8A51-2FA00E0B397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496" r="2839"/>
          <a:stretch/>
        </p:blipFill>
        <p:spPr>
          <a:xfrm>
            <a:off x="2312926" y="1746422"/>
            <a:ext cx="4837517" cy="2631391"/>
          </a:xfrm>
          <a:prstGeom prst="rect">
            <a:avLst/>
          </a:prstGeom>
        </p:spPr>
      </p:pic>
      <p:sp>
        <p:nvSpPr>
          <p:cNvPr id="3" name="Rectangle à coins arrondis 2">
            <a:extLst>
              <a:ext uri="{FF2B5EF4-FFF2-40B4-BE49-F238E27FC236}">
                <a16:creationId xmlns:a16="http://schemas.microsoft.com/office/drawing/2014/main" id="{282EDB74-DFD5-DB46-A273-97490846BDAC}"/>
              </a:ext>
            </a:extLst>
          </p:cNvPr>
          <p:cNvSpPr/>
          <p:nvPr/>
        </p:nvSpPr>
        <p:spPr>
          <a:xfrm>
            <a:off x="6296297" y="3866606"/>
            <a:ext cx="854146" cy="182880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C7A843FF-BAC2-8142-8ADA-30FFC8BCB185}"/>
              </a:ext>
            </a:extLst>
          </p:cNvPr>
          <p:cNvSpPr txBox="1"/>
          <p:nvPr/>
        </p:nvSpPr>
        <p:spPr>
          <a:xfrm>
            <a:off x="6183703" y="3819546"/>
            <a:ext cx="10070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anti-p24 (Gag)</a:t>
            </a:r>
          </a:p>
        </p:txBody>
      </p:sp>
    </p:spTree>
    <p:extLst>
      <p:ext uri="{BB962C8B-B14F-4D97-AF65-F5344CB8AC3E}">
        <p14:creationId xmlns:p14="http://schemas.microsoft.com/office/powerpoint/2010/main" val="16431380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5CC4FA5-2899-6F4B-83EB-4E7B9ADA4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76DE2-B6E6-8647-807C-517F97AA7782}" type="slidenum">
              <a:rPr lang="fr-FR" smtClean="0"/>
              <a:t>2</a:t>
            </a:fld>
            <a:endParaRPr lang="fr-FR"/>
          </a:p>
        </p:txBody>
      </p:sp>
      <p:grpSp>
        <p:nvGrpSpPr>
          <p:cNvPr id="33" name="Groupe 32">
            <a:extLst>
              <a:ext uri="{FF2B5EF4-FFF2-40B4-BE49-F238E27FC236}">
                <a16:creationId xmlns:a16="http://schemas.microsoft.com/office/drawing/2014/main" id="{B38F7D80-DF2D-D342-BBAB-EAE508922250}"/>
              </a:ext>
            </a:extLst>
          </p:cNvPr>
          <p:cNvGrpSpPr/>
          <p:nvPr/>
        </p:nvGrpSpPr>
        <p:grpSpPr>
          <a:xfrm>
            <a:off x="114451" y="1447188"/>
            <a:ext cx="5709198" cy="4719341"/>
            <a:chOff x="455837" y="903290"/>
            <a:chExt cx="6671796" cy="5508408"/>
          </a:xfrm>
        </p:grpSpPr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6C60BF90-74D1-A141-A489-82BA00FC041F}"/>
                </a:ext>
              </a:extLst>
            </p:cNvPr>
            <p:cNvSpPr txBox="1"/>
            <p:nvPr/>
          </p:nvSpPr>
          <p:spPr>
            <a:xfrm>
              <a:off x="988062" y="1713869"/>
              <a:ext cx="4315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MM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CC442DFE-6781-5B4E-B31A-65FEDB7B0F5B}"/>
                </a:ext>
              </a:extLst>
            </p:cNvPr>
            <p:cNvSpPr txBox="1"/>
            <p:nvPr/>
          </p:nvSpPr>
          <p:spPr>
            <a:xfrm>
              <a:off x="2962008" y="905267"/>
              <a:ext cx="2471227" cy="3053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 err="1"/>
                <a:t>Purified</a:t>
              </a:r>
              <a:r>
                <a:rPr lang="fr-FR" sz="1100" b="1" dirty="0"/>
                <a:t> SARS-CoV-2 </a:t>
              </a:r>
              <a:r>
                <a:rPr lang="fr-FR" sz="1100" b="1" dirty="0" err="1"/>
                <a:t>Pseudovirus</a:t>
              </a:r>
              <a:endParaRPr lang="fr-FR" sz="1100" b="1" dirty="0"/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942B2F2D-CA49-4546-8827-7346B62B19CE}"/>
                </a:ext>
              </a:extLst>
            </p:cNvPr>
            <p:cNvSpPr txBox="1"/>
            <p:nvPr/>
          </p:nvSpPr>
          <p:spPr>
            <a:xfrm>
              <a:off x="860760" y="911884"/>
              <a:ext cx="1694397" cy="3053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 err="1"/>
                <a:t>Lysate</a:t>
              </a:r>
              <a:endParaRPr lang="fr-FR" sz="1100" b="1" dirty="0"/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6DD584C8-CEBA-FF4F-AA75-28D73E73CE45}"/>
                </a:ext>
              </a:extLst>
            </p:cNvPr>
            <p:cNvSpPr txBox="1"/>
            <p:nvPr/>
          </p:nvSpPr>
          <p:spPr>
            <a:xfrm rot="16200000">
              <a:off x="2587451" y="1709170"/>
              <a:ext cx="3834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WT</a:t>
              </a:r>
            </a:p>
          </p:txBody>
        </p:sp>
        <p:cxnSp>
          <p:nvCxnSpPr>
            <p:cNvPr id="12" name="Connecteur droit 11">
              <a:extLst>
                <a:ext uri="{FF2B5EF4-FFF2-40B4-BE49-F238E27FC236}">
                  <a16:creationId xmlns:a16="http://schemas.microsoft.com/office/drawing/2014/main" id="{22F87339-7248-B245-8D12-CB0F790270C3}"/>
                </a:ext>
              </a:extLst>
            </p:cNvPr>
            <p:cNvCxnSpPr>
              <a:cxnSpLocks/>
            </p:cNvCxnSpPr>
            <p:nvPr/>
          </p:nvCxnSpPr>
          <p:spPr>
            <a:xfrm>
              <a:off x="1490484" y="1242743"/>
              <a:ext cx="43495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6540699D-064F-C143-A7AA-F0DBAAF1AFD1}"/>
                </a:ext>
              </a:extLst>
            </p:cNvPr>
            <p:cNvSpPr txBox="1"/>
            <p:nvPr/>
          </p:nvSpPr>
          <p:spPr>
            <a:xfrm rot="16200000">
              <a:off x="1507883" y="1619969"/>
              <a:ext cx="5004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Spike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30C88601-754C-974D-B894-BB3C9D332A94}"/>
                </a:ext>
              </a:extLst>
            </p:cNvPr>
            <p:cNvSpPr txBox="1"/>
            <p:nvPr/>
          </p:nvSpPr>
          <p:spPr>
            <a:xfrm rot="16200000">
              <a:off x="1986483" y="1622836"/>
              <a:ext cx="5613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 err="1"/>
                <a:t>Empty</a:t>
              </a:r>
              <a:endParaRPr lang="fr-FR" sz="1100" b="1" dirty="0"/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831FC6D7-5F82-E84B-A2FB-12E0E5FFE1A1}"/>
                </a:ext>
              </a:extLst>
            </p:cNvPr>
            <p:cNvSpPr txBox="1"/>
            <p:nvPr/>
          </p:nvSpPr>
          <p:spPr>
            <a:xfrm rot="16200000">
              <a:off x="3626866" y="1656695"/>
              <a:ext cx="4812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S13A</a:t>
              </a:r>
            </a:p>
          </p:txBody>
        </p:sp>
        <p:cxnSp>
          <p:nvCxnSpPr>
            <p:cNvPr id="16" name="Connecteur droit 15">
              <a:extLst>
                <a:ext uri="{FF2B5EF4-FFF2-40B4-BE49-F238E27FC236}">
                  <a16:creationId xmlns:a16="http://schemas.microsoft.com/office/drawing/2014/main" id="{F45F75DE-4152-FF43-BE63-3BFFBBEDB2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26640" y="1242743"/>
              <a:ext cx="3421998" cy="1168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4CD4E102-B03D-D64B-AB3E-284349108560}"/>
                </a:ext>
              </a:extLst>
            </p:cNvPr>
            <p:cNvSpPr txBox="1"/>
            <p:nvPr/>
          </p:nvSpPr>
          <p:spPr>
            <a:xfrm rot="16200000">
              <a:off x="4019352" y="1649701"/>
              <a:ext cx="5741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V635G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80757031-D2A4-A043-8952-7DC7E85DD90D}"/>
                </a:ext>
              </a:extLst>
            </p:cNvPr>
            <p:cNvSpPr txBox="1"/>
            <p:nvPr/>
          </p:nvSpPr>
          <p:spPr>
            <a:xfrm rot="16200000">
              <a:off x="4530563" y="1668014"/>
              <a:ext cx="5661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C671G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BF10D173-71F4-B34F-8BA6-5B841EE68A4C}"/>
                </a:ext>
              </a:extLst>
            </p:cNvPr>
            <p:cNvSpPr txBox="1"/>
            <p:nvPr/>
          </p:nvSpPr>
          <p:spPr>
            <a:xfrm rot="16200000">
              <a:off x="5043924" y="1544103"/>
              <a:ext cx="64472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V635G+</a:t>
              </a:r>
            </a:p>
            <a:p>
              <a:pPr algn="ctr"/>
              <a:r>
                <a:rPr lang="fr-FR" sz="1100" b="1" dirty="0"/>
                <a:t>C671G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72BC271F-F273-B347-B1F4-9C428695194D}"/>
                </a:ext>
              </a:extLst>
            </p:cNvPr>
            <p:cNvSpPr txBox="1"/>
            <p:nvPr/>
          </p:nvSpPr>
          <p:spPr>
            <a:xfrm rot="16200000">
              <a:off x="2972106" y="1632592"/>
              <a:ext cx="6174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RatG13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27D30AAD-B41E-2C40-9C5D-1D8CD96F55D6}"/>
                </a:ext>
              </a:extLst>
            </p:cNvPr>
            <p:cNvSpPr txBox="1"/>
            <p:nvPr/>
          </p:nvSpPr>
          <p:spPr>
            <a:xfrm rot="16200000">
              <a:off x="5766759" y="1628578"/>
              <a:ext cx="5613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 err="1"/>
                <a:t>Empty</a:t>
              </a:r>
              <a:endParaRPr lang="fr-FR" sz="1100" b="1" dirty="0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8AA7F4B2-97D0-E54A-9867-A8CB8E7E4D50}"/>
                </a:ext>
              </a:extLst>
            </p:cNvPr>
            <p:cNvSpPr txBox="1"/>
            <p:nvPr/>
          </p:nvSpPr>
          <p:spPr>
            <a:xfrm>
              <a:off x="5433236" y="903290"/>
              <a:ext cx="1694397" cy="3053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 err="1"/>
                <a:t>Lysate</a:t>
              </a:r>
              <a:endParaRPr lang="fr-FR" sz="1100" b="1" dirty="0"/>
            </a:p>
          </p:txBody>
        </p:sp>
        <p:cxnSp>
          <p:nvCxnSpPr>
            <p:cNvPr id="23" name="Connecteur droit 22">
              <a:extLst>
                <a:ext uri="{FF2B5EF4-FFF2-40B4-BE49-F238E27FC236}">
                  <a16:creationId xmlns:a16="http://schemas.microsoft.com/office/drawing/2014/main" id="{5D406C5F-B8A6-D342-9741-9098C196B2A2}"/>
                </a:ext>
              </a:extLst>
            </p:cNvPr>
            <p:cNvCxnSpPr>
              <a:cxnSpLocks/>
            </p:cNvCxnSpPr>
            <p:nvPr/>
          </p:nvCxnSpPr>
          <p:spPr>
            <a:xfrm>
              <a:off x="6134635" y="1254428"/>
              <a:ext cx="34552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D99B81FA-B85A-ED4F-B0A6-1A326EE0E26E}"/>
                </a:ext>
              </a:extLst>
            </p:cNvPr>
            <p:cNvSpPr txBox="1"/>
            <p:nvPr/>
          </p:nvSpPr>
          <p:spPr>
            <a:xfrm>
              <a:off x="488639" y="6150088"/>
              <a:ext cx="32893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15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B9EE0BFE-EE24-3247-AC9D-5F07E853BC6F}"/>
                </a:ext>
              </a:extLst>
            </p:cNvPr>
            <p:cNvSpPr txBox="1"/>
            <p:nvPr/>
          </p:nvSpPr>
          <p:spPr>
            <a:xfrm>
              <a:off x="488639" y="5647456"/>
              <a:ext cx="32893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25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4F67432E-F763-0C42-A542-A46418FC59BF}"/>
                </a:ext>
              </a:extLst>
            </p:cNvPr>
            <p:cNvSpPr txBox="1"/>
            <p:nvPr/>
          </p:nvSpPr>
          <p:spPr>
            <a:xfrm>
              <a:off x="488639" y="5964174"/>
              <a:ext cx="32893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20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6F118800-7ED4-1C49-BA7A-6553A5405117}"/>
                </a:ext>
              </a:extLst>
            </p:cNvPr>
            <p:cNvSpPr txBox="1"/>
            <p:nvPr/>
          </p:nvSpPr>
          <p:spPr>
            <a:xfrm>
              <a:off x="501797" y="4903985"/>
              <a:ext cx="32893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37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A74AE1B4-2E90-BE41-9F40-3E9B6D108859}"/>
                </a:ext>
              </a:extLst>
            </p:cNvPr>
            <p:cNvSpPr txBox="1"/>
            <p:nvPr/>
          </p:nvSpPr>
          <p:spPr>
            <a:xfrm>
              <a:off x="489942" y="4344304"/>
              <a:ext cx="555991" cy="3053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50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3C32ED7E-84EA-8047-BC8B-CD4D12462BAF}"/>
                </a:ext>
              </a:extLst>
            </p:cNvPr>
            <p:cNvSpPr txBox="1"/>
            <p:nvPr/>
          </p:nvSpPr>
          <p:spPr>
            <a:xfrm>
              <a:off x="455838" y="3753291"/>
              <a:ext cx="529254" cy="3053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75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2050DB50-F9D0-1F41-85CA-671A20C5834F}"/>
                </a:ext>
              </a:extLst>
            </p:cNvPr>
            <p:cNvSpPr txBox="1"/>
            <p:nvPr/>
          </p:nvSpPr>
          <p:spPr>
            <a:xfrm>
              <a:off x="455838" y="3396723"/>
              <a:ext cx="587542" cy="3053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100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C2A9A131-DCF5-0F43-9705-229D3024FA20}"/>
                </a:ext>
              </a:extLst>
            </p:cNvPr>
            <p:cNvSpPr txBox="1"/>
            <p:nvPr/>
          </p:nvSpPr>
          <p:spPr>
            <a:xfrm>
              <a:off x="455838" y="3087609"/>
              <a:ext cx="571149" cy="3053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150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1231B1D4-0D32-044B-BE96-C52E0FEA63C6}"/>
                </a:ext>
              </a:extLst>
            </p:cNvPr>
            <p:cNvSpPr txBox="1"/>
            <p:nvPr/>
          </p:nvSpPr>
          <p:spPr>
            <a:xfrm>
              <a:off x="455837" y="2767020"/>
              <a:ext cx="584308" cy="3053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250</a:t>
              </a:r>
            </a:p>
          </p:txBody>
        </p:sp>
      </p:grpSp>
      <p:grpSp>
        <p:nvGrpSpPr>
          <p:cNvPr id="60" name="Groupe 59">
            <a:extLst>
              <a:ext uri="{FF2B5EF4-FFF2-40B4-BE49-F238E27FC236}">
                <a16:creationId xmlns:a16="http://schemas.microsoft.com/office/drawing/2014/main" id="{59663B4C-3DD8-1B4D-8ED3-845FBC1FCDB3}"/>
              </a:ext>
            </a:extLst>
          </p:cNvPr>
          <p:cNvGrpSpPr/>
          <p:nvPr/>
        </p:nvGrpSpPr>
        <p:grpSpPr>
          <a:xfrm>
            <a:off x="5921796" y="1439662"/>
            <a:ext cx="6148692" cy="5103690"/>
            <a:chOff x="7126424" y="929783"/>
            <a:chExt cx="6542862" cy="5674301"/>
          </a:xfrm>
        </p:grpSpPr>
        <p:pic>
          <p:nvPicPr>
            <p:cNvPr id="34" name="Image 33">
              <a:extLst>
                <a:ext uri="{FF2B5EF4-FFF2-40B4-BE49-F238E27FC236}">
                  <a16:creationId xmlns:a16="http://schemas.microsoft.com/office/drawing/2014/main" id="{6BB0D83D-39D0-CE41-854A-DD213BFA97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555932" y="2013001"/>
              <a:ext cx="5815371" cy="4591083"/>
            </a:xfrm>
            <a:prstGeom prst="rect">
              <a:avLst/>
            </a:prstGeom>
          </p:spPr>
        </p:pic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8222209A-8B8F-0044-BD12-A744F1DED70A}"/>
                </a:ext>
              </a:extLst>
            </p:cNvPr>
            <p:cNvSpPr txBox="1"/>
            <p:nvPr/>
          </p:nvSpPr>
          <p:spPr>
            <a:xfrm>
              <a:off x="7633081" y="1635752"/>
              <a:ext cx="4315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MM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3648ADE8-E48A-D64B-A45C-5F5D9C42B38D}"/>
                </a:ext>
              </a:extLst>
            </p:cNvPr>
            <p:cNvSpPr txBox="1"/>
            <p:nvPr/>
          </p:nvSpPr>
          <p:spPr>
            <a:xfrm>
              <a:off x="9724642" y="956153"/>
              <a:ext cx="2250247" cy="2908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 err="1"/>
                <a:t>Purified</a:t>
              </a:r>
              <a:r>
                <a:rPr lang="fr-FR" sz="1100" b="1" dirty="0"/>
                <a:t> SARS-CoV-2 </a:t>
              </a:r>
              <a:r>
                <a:rPr lang="fr-FR" sz="1100" b="1" dirty="0" err="1"/>
                <a:t>Pseudovirus</a:t>
              </a:r>
              <a:endParaRPr lang="fr-FR" sz="1100" b="1" dirty="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0FBC4291-6D69-DD46-964C-522F27262DF7}"/>
                </a:ext>
              </a:extLst>
            </p:cNvPr>
            <p:cNvSpPr txBox="1"/>
            <p:nvPr/>
          </p:nvSpPr>
          <p:spPr>
            <a:xfrm>
              <a:off x="7545040" y="929783"/>
              <a:ext cx="1694398" cy="290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 err="1"/>
                <a:t>Lysate</a:t>
              </a:r>
              <a:endParaRPr lang="fr-FR" sz="1100" b="1" dirty="0"/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B45C90B6-D388-1944-82FD-2DDAAE838413}"/>
                </a:ext>
              </a:extLst>
            </p:cNvPr>
            <p:cNvSpPr txBox="1"/>
            <p:nvPr/>
          </p:nvSpPr>
          <p:spPr>
            <a:xfrm rot="16200000">
              <a:off x="9143411" y="1667106"/>
              <a:ext cx="3834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WT</a:t>
              </a:r>
            </a:p>
          </p:txBody>
        </p:sp>
        <p:cxnSp>
          <p:nvCxnSpPr>
            <p:cNvPr id="39" name="Connecteur droit 38">
              <a:extLst>
                <a:ext uri="{FF2B5EF4-FFF2-40B4-BE49-F238E27FC236}">
                  <a16:creationId xmlns:a16="http://schemas.microsoft.com/office/drawing/2014/main" id="{283057FA-1F54-8E49-8E4C-1821EAF586E5}"/>
                </a:ext>
              </a:extLst>
            </p:cNvPr>
            <p:cNvCxnSpPr>
              <a:cxnSpLocks/>
            </p:cNvCxnSpPr>
            <p:nvPr/>
          </p:nvCxnSpPr>
          <p:spPr>
            <a:xfrm>
              <a:off x="8142637" y="1293628"/>
              <a:ext cx="43495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DF61F459-28AA-0F4B-A5C5-AE33684D44CE}"/>
                </a:ext>
              </a:extLst>
            </p:cNvPr>
            <p:cNvSpPr txBox="1"/>
            <p:nvPr/>
          </p:nvSpPr>
          <p:spPr>
            <a:xfrm rot="16200000">
              <a:off x="8152902" y="1541853"/>
              <a:ext cx="5004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Spike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6202F468-60E1-124E-957F-198B9608EDFB}"/>
                </a:ext>
              </a:extLst>
            </p:cNvPr>
            <p:cNvSpPr txBox="1"/>
            <p:nvPr/>
          </p:nvSpPr>
          <p:spPr>
            <a:xfrm rot="16200000">
              <a:off x="8627682" y="1610578"/>
              <a:ext cx="5613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 err="1"/>
                <a:t>Empty</a:t>
              </a:r>
              <a:endParaRPr lang="fr-FR" sz="1100" b="1" dirty="0"/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A5C2CE0D-5B20-1749-9464-4F4A6DBF2C20}"/>
                </a:ext>
              </a:extLst>
            </p:cNvPr>
            <p:cNvSpPr txBox="1"/>
            <p:nvPr/>
          </p:nvSpPr>
          <p:spPr>
            <a:xfrm rot="16200000">
              <a:off x="10202297" y="1603954"/>
              <a:ext cx="4812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S13A</a:t>
              </a:r>
            </a:p>
          </p:txBody>
        </p:sp>
        <p:cxnSp>
          <p:nvCxnSpPr>
            <p:cNvPr id="43" name="Connecteur droit 42">
              <a:extLst>
                <a:ext uri="{FF2B5EF4-FFF2-40B4-BE49-F238E27FC236}">
                  <a16:creationId xmlns:a16="http://schemas.microsoft.com/office/drawing/2014/main" id="{97A9D339-D4F3-254F-A3A8-42E2CAE97A3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978793" y="1293628"/>
              <a:ext cx="3421998" cy="1168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6A8E9EA6-1541-8C47-A02F-B8FD53EB3EF8}"/>
                </a:ext>
              </a:extLst>
            </p:cNvPr>
            <p:cNvSpPr txBox="1"/>
            <p:nvPr/>
          </p:nvSpPr>
          <p:spPr>
            <a:xfrm rot="16200000">
              <a:off x="10733010" y="1642930"/>
              <a:ext cx="5741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V635G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768AB967-DF59-C24F-9A9E-EBA99B5B806B}"/>
                </a:ext>
              </a:extLst>
            </p:cNvPr>
            <p:cNvSpPr txBox="1"/>
            <p:nvPr/>
          </p:nvSpPr>
          <p:spPr>
            <a:xfrm rot="16200000">
              <a:off x="11241869" y="1637627"/>
              <a:ext cx="5661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C671G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21919371-96C5-0C40-B9E4-F9DB78217A19}"/>
                </a:ext>
              </a:extLst>
            </p:cNvPr>
            <p:cNvSpPr txBox="1"/>
            <p:nvPr/>
          </p:nvSpPr>
          <p:spPr>
            <a:xfrm rot="16200000">
              <a:off x="11756371" y="1560451"/>
              <a:ext cx="64472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V635G+</a:t>
              </a:r>
            </a:p>
            <a:p>
              <a:pPr algn="ctr"/>
              <a:r>
                <a:rPr lang="fr-FR" sz="1100" b="1" dirty="0"/>
                <a:t>C671G</a:t>
              </a:r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D74D1822-6E4D-004D-899B-54DB540D8AA1}"/>
                </a:ext>
              </a:extLst>
            </p:cNvPr>
            <p:cNvSpPr txBox="1"/>
            <p:nvPr/>
          </p:nvSpPr>
          <p:spPr>
            <a:xfrm rot="16200000">
              <a:off x="9583959" y="1658714"/>
              <a:ext cx="6174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/>
                <a:t>RatG13</a:t>
              </a: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1BDF0D78-5D13-FE43-BEA5-0687A1E1D4DB}"/>
                </a:ext>
              </a:extLst>
            </p:cNvPr>
            <p:cNvSpPr txBox="1"/>
            <p:nvPr/>
          </p:nvSpPr>
          <p:spPr>
            <a:xfrm rot="16200000">
              <a:off x="12343403" y="1665650"/>
              <a:ext cx="5613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 err="1"/>
                <a:t>Empty</a:t>
              </a:r>
              <a:endParaRPr lang="fr-FR" sz="1100" b="1" dirty="0"/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47C14368-66A4-0B42-B2A3-0A9A6EC1D61C}"/>
                </a:ext>
              </a:extLst>
            </p:cNvPr>
            <p:cNvSpPr txBox="1"/>
            <p:nvPr/>
          </p:nvSpPr>
          <p:spPr>
            <a:xfrm>
              <a:off x="11974888" y="990773"/>
              <a:ext cx="1694398" cy="290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 err="1"/>
                <a:t>Lysate</a:t>
              </a:r>
              <a:endParaRPr lang="fr-FR" sz="1100" b="1" dirty="0"/>
            </a:p>
          </p:txBody>
        </p:sp>
        <p:cxnSp>
          <p:nvCxnSpPr>
            <p:cNvPr id="50" name="Connecteur droit 49">
              <a:extLst>
                <a:ext uri="{FF2B5EF4-FFF2-40B4-BE49-F238E27FC236}">
                  <a16:creationId xmlns:a16="http://schemas.microsoft.com/office/drawing/2014/main" id="{F529125E-7960-7F4F-8804-3A1C03C9EAE7}"/>
                </a:ext>
              </a:extLst>
            </p:cNvPr>
            <p:cNvCxnSpPr>
              <a:cxnSpLocks/>
            </p:cNvCxnSpPr>
            <p:nvPr/>
          </p:nvCxnSpPr>
          <p:spPr>
            <a:xfrm>
              <a:off x="12593073" y="1308886"/>
              <a:ext cx="34552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47088E62-ACF9-1C4F-AAEA-D5619D47BD8F}"/>
                </a:ext>
              </a:extLst>
            </p:cNvPr>
            <p:cNvSpPr txBox="1"/>
            <p:nvPr/>
          </p:nvSpPr>
          <p:spPr>
            <a:xfrm>
              <a:off x="7184907" y="573981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15</a:t>
              </a:r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85089AA1-208E-6F4C-B9FC-314C18D300B9}"/>
                </a:ext>
              </a:extLst>
            </p:cNvPr>
            <p:cNvSpPr txBox="1"/>
            <p:nvPr/>
          </p:nvSpPr>
          <p:spPr>
            <a:xfrm>
              <a:off x="7184907" y="5237178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25</a:t>
              </a:r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8FD15388-1D7A-334C-9E0B-DD692AE5D3E6}"/>
                </a:ext>
              </a:extLst>
            </p:cNvPr>
            <p:cNvSpPr txBox="1"/>
            <p:nvPr/>
          </p:nvSpPr>
          <p:spPr>
            <a:xfrm>
              <a:off x="7184907" y="555389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20</a:t>
              </a:r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D0C1BE05-1DA6-654D-826F-55CE18CCA881}"/>
                </a:ext>
              </a:extLst>
            </p:cNvPr>
            <p:cNvSpPr txBox="1"/>
            <p:nvPr/>
          </p:nvSpPr>
          <p:spPr>
            <a:xfrm>
              <a:off x="7168708" y="460490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37</a:t>
              </a:r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051183B4-3578-274E-BAB3-26576AF2B632}"/>
                </a:ext>
              </a:extLst>
            </p:cNvPr>
            <p:cNvSpPr txBox="1"/>
            <p:nvPr/>
          </p:nvSpPr>
          <p:spPr>
            <a:xfrm>
              <a:off x="7169273" y="4155524"/>
              <a:ext cx="463807" cy="290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50</a:t>
              </a:r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E3A988C0-9F8B-3844-BC63-45548F99496F}"/>
                </a:ext>
              </a:extLst>
            </p:cNvPr>
            <p:cNvSpPr txBox="1"/>
            <p:nvPr/>
          </p:nvSpPr>
          <p:spPr>
            <a:xfrm>
              <a:off x="7168318" y="3665518"/>
              <a:ext cx="464763" cy="290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75</a:t>
              </a:r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76796ED3-43F3-8C43-A38F-8BB4A7DF1F8B}"/>
                </a:ext>
              </a:extLst>
            </p:cNvPr>
            <p:cNvSpPr txBox="1"/>
            <p:nvPr/>
          </p:nvSpPr>
          <p:spPr>
            <a:xfrm>
              <a:off x="7142817" y="3308951"/>
              <a:ext cx="490265" cy="290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100</a:t>
              </a:r>
            </a:p>
          </p:txBody>
        </p:sp>
        <p:sp>
          <p:nvSpPr>
            <p:cNvPr id="58" name="ZoneTexte 57">
              <a:extLst>
                <a:ext uri="{FF2B5EF4-FFF2-40B4-BE49-F238E27FC236}">
                  <a16:creationId xmlns:a16="http://schemas.microsoft.com/office/drawing/2014/main" id="{EA0C0405-B9F0-7A4A-98B5-18910F3E85B2}"/>
                </a:ext>
              </a:extLst>
            </p:cNvPr>
            <p:cNvSpPr txBox="1"/>
            <p:nvPr/>
          </p:nvSpPr>
          <p:spPr>
            <a:xfrm>
              <a:off x="7126424" y="2999837"/>
              <a:ext cx="506657" cy="290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150</a:t>
              </a:r>
            </a:p>
          </p:txBody>
        </p:sp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F33021BF-1F70-3141-978F-2E1422D345FE}"/>
                </a:ext>
              </a:extLst>
            </p:cNvPr>
            <p:cNvSpPr txBox="1"/>
            <p:nvPr/>
          </p:nvSpPr>
          <p:spPr>
            <a:xfrm>
              <a:off x="7139584" y="2679247"/>
              <a:ext cx="493497" cy="290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250</a:t>
              </a:r>
            </a:p>
          </p:txBody>
        </p:sp>
      </p:grpSp>
      <p:pic>
        <p:nvPicPr>
          <p:cNvPr id="62" name="Image 61">
            <a:extLst>
              <a:ext uri="{FF2B5EF4-FFF2-40B4-BE49-F238E27FC236}">
                <a16:creationId xmlns:a16="http://schemas.microsoft.com/office/drawing/2014/main" id="{FE6ACB81-EF6C-0548-A41F-BE8BE092C0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1398" y="2421127"/>
            <a:ext cx="4858392" cy="3994209"/>
          </a:xfrm>
          <a:prstGeom prst="rect">
            <a:avLst/>
          </a:prstGeom>
        </p:spPr>
      </p:pic>
      <p:sp>
        <p:nvSpPr>
          <p:cNvPr id="61" name="Rectangle 60">
            <a:extLst>
              <a:ext uri="{FF2B5EF4-FFF2-40B4-BE49-F238E27FC236}">
                <a16:creationId xmlns:a16="http://schemas.microsoft.com/office/drawing/2014/main" id="{62FCAB43-F85B-D145-B4B3-A1C5383E9076}"/>
              </a:ext>
            </a:extLst>
          </p:cNvPr>
          <p:cNvSpPr/>
          <p:nvPr/>
        </p:nvSpPr>
        <p:spPr>
          <a:xfrm>
            <a:off x="0" y="10267"/>
            <a:ext cx="12192000" cy="415381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30D500BA-1CE6-7D4B-BE32-C0DDAA517030}"/>
              </a:ext>
            </a:extLst>
          </p:cNvPr>
          <p:cNvSpPr txBox="1"/>
          <p:nvPr/>
        </p:nvSpPr>
        <p:spPr>
          <a:xfrm>
            <a:off x="0" y="38520"/>
            <a:ext cx="2065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estern Blot Fig. 3E</a:t>
            </a:r>
          </a:p>
        </p:txBody>
      </p:sp>
    </p:spTree>
    <p:extLst>
      <p:ext uri="{BB962C8B-B14F-4D97-AF65-F5344CB8AC3E}">
        <p14:creationId xmlns:p14="http://schemas.microsoft.com/office/powerpoint/2010/main" val="285233371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7</Words>
  <Application>Microsoft Macintosh PowerPoint</Application>
  <PresentationFormat>Grand écran</PresentationFormat>
  <Paragraphs>5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isa C.</dc:creator>
  <cp:lastModifiedBy>Stacy</cp:lastModifiedBy>
  <cp:revision>3</cp:revision>
  <dcterms:created xsi:type="dcterms:W3CDTF">2021-05-26T10:20:25Z</dcterms:created>
  <dcterms:modified xsi:type="dcterms:W3CDTF">2021-05-26T10:51:26Z</dcterms:modified>
</cp:coreProperties>
</file>